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2AA73-9E24-4649-AAD3-2E3CAC7F20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5DD3BD-041D-472F-874E-8A1A0DCD0E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1759B-2536-45F4-B6BF-5CDFCBD2B3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7889D-07B9-435D-B19E-18E94B478A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CCFF7-A483-4C5F-A45D-D78AC4066A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28E87-A152-4467-BA78-D1E2E0A79D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63697-B11F-415D-AD70-A4368FCB1F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BAA75-50F8-4471-8BCA-E560422E3F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CC296-B013-4BDF-9505-B29BB9080E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9EAE8-B90B-4AF0-BDAE-F74F6FF129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9907C-D50B-459E-8344-CD5E461370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3FB97-EB11-4F12-8617-A15BA47D12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E939C8-18D1-46E3-B57F-2411B072D6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762120" y="2362320"/>
            <a:ext cx="7226280" cy="990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2" name=""/>
          <p:cNvGraphicFramePr/>
          <p:nvPr/>
        </p:nvGraphicFramePr>
        <p:xfrm>
          <a:off x="914400" y="4267080"/>
          <a:ext cx="6804000" cy="69372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914400" y="4267080"/>
                    <a:ext cx="6804000" cy="693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1050840" y="201780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942120" y="2076480"/>
            <a:ext cx="684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Book Antiqua"/>
              </a:rPr>
              <a:t>A    A1   B    B1   C   C1   D    D1     E      E1     F   F1     G   G1    H   H1    I     I1      J     J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56800" y="3905280"/>
            <a:ext cx="6926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Book Antiqua"/>
              </a:rPr>
              <a:t>K    K1    L    L1   M   M1   N   N1     O     O1   P    P1   Q   Q1    R    R1     S    S1    T     T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02160" y="725400"/>
            <a:ext cx="1532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TP53ALU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523880" y="1828800"/>
          <a:ext cx="6324840" cy="838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3880" y="1828800"/>
                    <a:ext cx="6324840" cy="838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"/>
          <p:cNvSpPr/>
          <p:nvPr/>
        </p:nvSpPr>
        <p:spPr>
          <a:xfrm>
            <a:off x="1494720" y="1447920"/>
            <a:ext cx="661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Book Antiqua"/>
              </a:rPr>
              <a:t>A   A1    B   B1   C    C1   D   D1  E   E1   F   F1   G     G1   H   H1    I     I1      J     J1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496520" y="3200400"/>
            <a:ext cx="587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Book Antiqua"/>
              </a:rPr>
              <a:t>   </a:t>
            </a:r>
            <a:r>
              <a:rPr b="0" lang="pt-BR" sz="1400" spc="-1" strike="noStrike">
                <a:solidFill>
                  <a:srgbClr val="000000"/>
                </a:solidFill>
                <a:latin typeface="Book Antiqua"/>
              </a:rPr>
              <a:t>K   K1   L  L1   M  M1  N  N1  O  O1  P   P1  Q  Q1    R   R1    S  S1  T  T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511640" y="496800"/>
            <a:ext cx="1415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PCR15.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990720" y="3003480"/>
          <a:ext cx="6933960" cy="1914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90720" y="3003480"/>
                    <a:ext cx="6933960" cy="191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5" name=""/>
          <p:cNvSpPr/>
          <p:nvPr/>
        </p:nvSpPr>
        <p:spPr>
          <a:xfrm>
            <a:off x="1508040" y="338940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50920" y="3429000"/>
            <a:ext cx="6240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ook Antiqua"/>
              </a:rPr>
              <a:t>  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569240" y="3429000"/>
            <a:ext cx="6148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ook Antiqua"/>
              </a:rPr>
              <a:t>K  K1  L   L1  M  M1   N   N1   O  O1   P    P1   Q   Q1   R    R1   S    S1   T    T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842160" y="4761000"/>
            <a:ext cx="183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777000" y="4648320"/>
            <a:ext cx="46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6934320" y="4648320"/>
            <a:ext cx="0" cy="914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LEGEND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Twenty normal women were tested for MSI using the PCR 15-1 and TP53Alu markers. Each normal woman sample correspond to one letter (for example, A represents the first sample of the first control woman and A1 her second sample collected 3 months latter). We noted only one case (S and S1) in which the second sample indicated by na arrow (S1) showed an extra band with the marker PCR15.1.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14T18:56:22Z</dcterms:created>
  <dc:creator>JORGE</dc:creator>
  <dc:description/>
  <dc:language>en-US</dc:language>
  <cp:lastModifiedBy>Sandra</cp:lastModifiedBy>
  <dcterms:modified xsi:type="dcterms:W3CDTF">2004-09-15T01:44:54Z</dcterms:modified>
  <cp:revision>13</cp:revision>
  <dc:subject/>
  <dc:title>Slide 1</dc:title>
</cp:coreProperties>
</file>